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3" r:id="rId4"/>
    <p:sldId id="262" r:id="rId5"/>
    <p:sldId id="258" r:id="rId6"/>
    <p:sldId id="259" r:id="rId7"/>
    <p:sldId id="261" r:id="rId8"/>
    <p:sldId id="260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Editor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CBEAB27-C79E-4C53-9BC0-B67F48DD3516}" v="21" dt="2025-02-12T04:11:29.7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62" autoAdjust="0"/>
    <p:restoredTop sz="94660"/>
  </p:normalViewPr>
  <p:slideViewPr>
    <p:cSldViewPr snapToGrid="0">
      <p:cViewPr varScale="1">
        <p:scale>
          <a:sx n="97" d="100"/>
          <a:sy n="97" d="100"/>
        </p:scale>
        <p:origin x="998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71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553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473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304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22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402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7104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1207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644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331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306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3A51C-9051-4CAB-99C7-078FE1557A86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0218B3-1FC4-419E-A6E2-11B5A8E15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066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2F850DF6-C479-A79C-A1E5-A9A76993A7C8}"/>
              </a:ext>
            </a:extLst>
          </p:cNvPr>
          <p:cNvGrpSpPr/>
          <p:nvPr/>
        </p:nvGrpSpPr>
        <p:grpSpPr>
          <a:xfrm>
            <a:off x="47266" y="501201"/>
            <a:ext cx="9096734" cy="6186196"/>
            <a:chOff x="47266" y="501201"/>
            <a:chExt cx="9096734" cy="6186196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F0B40AC0-D417-4285-A7EC-07E798C1E7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266" y="501201"/>
              <a:ext cx="9096734" cy="6186196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BCD0D56-AADA-421F-B03E-4F02AF6C7ADB}"/>
                </a:ext>
              </a:extLst>
            </p:cNvPr>
            <p:cNvSpPr txBox="1"/>
            <p:nvPr/>
          </p:nvSpPr>
          <p:spPr>
            <a:xfrm>
              <a:off x="3369131" y="1002657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2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69C266A-BDA4-FFC3-DE28-93504B3DE87D}"/>
                </a:ext>
              </a:extLst>
            </p:cNvPr>
            <p:cNvSpPr txBox="1"/>
            <p:nvPr/>
          </p:nvSpPr>
          <p:spPr>
            <a:xfrm>
              <a:off x="1426030" y="1002656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7EE2ECF-62C6-F323-0F33-49C5048A5356}"/>
                </a:ext>
              </a:extLst>
            </p:cNvPr>
            <p:cNvSpPr txBox="1"/>
            <p:nvPr/>
          </p:nvSpPr>
          <p:spPr>
            <a:xfrm>
              <a:off x="5512837" y="1002656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3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7D17C594-7A94-B858-C238-4B48E7DB5C7F}"/>
                </a:ext>
              </a:extLst>
            </p:cNvPr>
            <p:cNvSpPr txBox="1"/>
            <p:nvPr/>
          </p:nvSpPr>
          <p:spPr>
            <a:xfrm>
              <a:off x="7532916" y="1002656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4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AFD46A5-B20E-6F47-7F61-34397E2F8664}"/>
              </a:ext>
            </a:extLst>
          </p:cNvPr>
          <p:cNvSpPr txBox="1"/>
          <p:nvPr/>
        </p:nvSpPr>
        <p:spPr>
          <a:xfrm rot="16200000">
            <a:off x="-1268058" y="2723962"/>
            <a:ext cx="2993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prescription rate (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5B2F1B1-B750-43B9-ABB9-11AC5C11C627}"/>
              </a:ext>
            </a:extLst>
          </p:cNvPr>
          <p:cNvSpPr txBox="1"/>
          <p:nvPr/>
        </p:nvSpPr>
        <p:spPr>
          <a:xfrm>
            <a:off x="149286" y="46652"/>
            <a:ext cx="87722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es of antiviral prescription by generalists among patients with an immunosuppressed status before and after viewing the educational film. Pre, before viewing the educational film; post, after viewing the educational film.</a:t>
            </a:r>
            <a:endParaRPr kumimoji="1" lang="en-US" altLang="ja-JP" sz="1600" b="1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28273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19AFE349-AB54-ECAB-2816-2FF31FDC3DD6}"/>
              </a:ext>
            </a:extLst>
          </p:cNvPr>
          <p:cNvGrpSpPr/>
          <p:nvPr/>
        </p:nvGrpSpPr>
        <p:grpSpPr>
          <a:xfrm>
            <a:off x="0" y="523839"/>
            <a:ext cx="9144000" cy="6218339"/>
            <a:chOff x="0" y="523839"/>
            <a:chExt cx="9144000" cy="6218339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505BF8DD-16F5-4724-B032-306490459C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3839"/>
              <a:ext cx="9144000" cy="6218339"/>
            </a:xfrm>
            <a:prstGeom prst="rect">
              <a:avLst/>
            </a:prstGeom>
          </p:spPr>
        </p:pic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689B64A4-4487-B5BE-0F36-BEA13CEC7A17}"/>
                </a:ext>
              </a:extLst>
            </p:cNvPr>
            <p:cNvSpPr txBox="1"/>
            <p:nvPr/>
          </p:nvSpPr>
          <p:spPr>
            <a:xfrm>
              <a:off x="3369131" y="1036782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6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C73A1665-A7C6-3697-85EF-21FCFEAABC02}"/>
                </a:ext>
              </a:extLst>
            </p:cNvPr>
            <p:cNvSpPr txBox="1"/>
            <p:nvPr/>
          </p:nvSpPr>
          <p:spPr>
            <a:xfrm>
              <a:off x="1426030" y="1035317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5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88508131-B665-5B47-7917-20FCFD39AFEE}"/>
                </a:ext>
              </a:extLst>
            </p:cNvPr>
            <p:cNvSpPr txBox="1"/>
            <p:nvPr/>
          </p:nvSpPr>
          <p:spPr>
            <a:xfrm>
              <a:off x="5512837" y="1035320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7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69A6CF24-3B94-E8F0-1E25-EBA816705FB1}"/>
                </a:ext>
              </a:extLst>
            </p:cNvPr>
            <p:cNvSpPr txBox="1"/>
            <p:nvPr/>
          </p:nvSpPr>
          <p:spPr>
            <a:xfrm>
              <a:off x="7532916" y="1035316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8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テキスト ボックス 2">
            <a:extLst>
              <a:ext uri="{FF2B5EF4-FFF2-40B4-BE49-F238E27FC236}">
                <a16:creationId xmlns:a16="http://schemas.microsoft.com/office/drawing/2014/main" id="{03B4B4C6-7FC8-ABFC-0E4F-88433B67032A}"/>
              </a:ext>
            </a:extLst>
          </p:cNvPr>
          <p:cNvSpPr txBox="1"/>
          <p:nvPr/>
        </p:nvSpPr>
        <p:spPr>
          <a:xfrm rot="16200000">
            <a:off x="-1268058" y="2748676"/>
            <a:ext cx="2993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prescription rate (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5B2F1B1-B750-43B9-ABB9-11AC5C11C627}"/>
              </a:ext>
            </a:extLst>
          </p:cNvPr>
          <p:cNvSpPr txBox="1"/>
          <p:nvPr/>
        </p:nvSpPr>
        <p:spPr>
          <a:xfrm>
            <a:off x="205271" y="185285"/>
            <a:ext cx="857990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es of antiviral prescription by generalists among patients with obesity before and after viewing the educational film. Pre, before viewing the educational film; post, after viewing the educational film.</a:t>
            </a:r>
            <a:endParaRPr kumimoji="1" lang="ja-JP" altLang="en-US" sz="1600" b="1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7633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47569BAC-EA35-04BE-ECAE-CDB136C82561}"/>
              </a:ext>
            </a:extLst>
          </p:cNvPr>
          <p:cNvGrpSpPr/>
          <p:nvPr/>
        </p:nvGrpSpPr>
        <p:grpSpPr>
          <a:xfrm>
            <a:off x="0" y="523839"/>
            <a:ext cx="9163389" cy="6231524"/>
            <a:chOff x="0" y="523839"/>
            <a:chExt cx="9163389" cy="6231524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0DEA9118-04CE-48D9-8DCF-CC21AF5CD4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3839"/>
              <a:ext cx="9163389" cy="6231524"/>
            </a:xfrm>
            <a:prstGeom prst="rect">
              <a:avLst/>
            </a:prstGeom>
          </p:spPr>
        </p:pic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2E84626D-3496-E6E5-F1AD-6328636B2D73}"/>
                </a:ext>
              </a:extLst>
            </p:cNvPr>
            <p:cNvSpPr txBox="1"/>
            <p:nvPr/>
          </p:nvSpPr>
          <p:spPr>
            <a:xfrm>
              <a:off x="3358245" y="1036788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96249A5D-539F-2A2C-72A2-E1211CA8E581}"/>
                </a:ext>
              </a:extLst>
            </p:cNvPr>
            <p:cNvSpPr txBox="1"/>
            <p:nvPr/>
          </p:nvSpPr>
          <p:spPr>
            <a:xfrm>
              <a:off x="1426030" y="1036786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9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3ABA5C0E-6C71-8379-F5C8-58E34FD2574C}"/>
                </a:ext>
              </a:extLst>
            </p:cNvPr>
            <p:cNvSpPr txBox="1"/>
            <p:nvPr/>
          </p:nvSpPr>
          <p:spPr>
            <a:xfrm>
              <a:off x="5491065" y="1036786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1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48508132-80BF-D86B-A7F6-CCBDF5326CD0}"/>
                </a:ext>
              </a:extLst>
            </p:cNvPr>
            <p:cNvSpPr txBox="1"/>
            <p:nvPr/>
          </p:nvSpPr>
          <p:spPr>
            <a:xfrm>
              <a:off x="7511144" y="1036785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2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テキスト ボックス 2">
            <a:extLst>
              <a:ext uri="{FF2B5EF4-FFF2-40B4-BE49-F238E27FC236}">
                <a16:creationId xmlns:a16="http://schemas.microsoft.com/office/drawing/2014/main" id="{CB9FAB15-FD6D-9297-A6F7-59653D2EF570}"/>
              </a:ext>
            </a:extLst>
          </p:cNvPr>
          <p:cNvSpPr txBox="1"/>
          <p:nvPr/>
        </p:nvSpPr>
        <p:spPr>
          <a:xfrm rot="16200000">
            <a:off x="-1268058" y="2748676"/>
            <a:ext cx="2993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prescription rate (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0724899-5D96-476E-8A84-FD3A832513D4}"/>
              </a:ext>
            </a:extLst>
          </p:cNvPr>
          <p:cNvSpPr txBox="1"/>
          <p:nvPr/>
        </p:nvSpPr>
        <p:spPr>
          <a:xfrm>
            <a:off x="205271" y="185285"/>
            <a:ext cx="875337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es of antiviral prescription by generalists among patients with hypertension or hyperlipidemia before and after viewing the educational film. Pre, before viewing the educational film; post, after viewing the educational film.</a:t>
            </a:r>
            <a:endParaRPr kumimoji="1" lang="ja-JP" altLang="en-US" sz="1600" b="1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3936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C68DFBFF-9EFE-98CF-F6D7-D9A6CF595F8D}"/>
              </a:ext>
            </a:extLst>
          </p:cNvPr>
          <p:cNvGrpSpPr/>
          <p:nvPr/>
        </p:nvGrpSpPr>
        <p:grpSpPr>
          <a:xfrm>
            <a:off x="0" y="604343"/>
            <a:ext cx="9099892" cy="6188343"/>
            <a:chOff x="0" y="604343"/>
            <a:chExt cx="9099892" cy="6188343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B871F90D-07FE-4DFC-A487-A092771035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604343"/>
              <a:ext cx="9099892" cy="6188343"/>
            </a:xfrm>
            <a:prstGeom prst="rect">
              <a:avLst/>
            </a:prstGeom>
          </p:spPr>
        </p:pic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E4895FBE-C7C7-8A92-3F7A-3CA2FADB266A}"/>
                </a:ext>
              </a:extLst>
            </p:cNvPr>
            <p:cNvSpPr txBox="1"/>
            <p:nvPr/>
          </p:nvSpPr>
          <p:spPr>
            <a:xfrm>
              <a:off x="3292929" y="1741715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4</a:t>
              </a:r>
              <a:endParaRPr kumimoji="1" lang="ja-JP" altLang="en-US" sz="1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F27A6804-D3CC-68F5-D72B-95187CECFBDE}"/>
                </a:ext>
              </a:extLst>
            </p:cNvPr>
            <p:cNvSpPr txBox="1"/>
            <p:nvPr/>
          </p:nvSpPr>
          <p:spPr>
            <a:xfrm>
              <a:off x="1349828" y="1741715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3</a:t>
              </a:r>
              <a:endParaRPr kumimoji="1" lang="ja-JP" altLang="en-US" sz="1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43F2FF12-D28B-B89B-D54E-6240186080EF}"/>
                </a:ext>
              </a:extLst>
            </p:cNvPr>
            <p:cNvSpPr txBox="1"/>
            <p:nvPr/>
          </p:nvSpPr>
          <p:spPr>
            <a:xfrm>
              <a:off x="5436635" y="1741715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5</a:t>
              </a:r>
              <a:endParaRPr kumimoji="1" lang="ja-JP" altLang="en-US" sz="1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64E85935-C962-1C7A-A5CA-B4AE1FBCC109}"/>
                </a:ext>
              </a:extLst>
            </p:cNvPr>
            <p:cNvSpPr txBox="1"/>
            <p:nvPr/>
          </p:nvSpPr>
          <p:spPr>
            <a:xfrm>
              <a:off x="7456714" y="1741715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6</a:t>
              </a:r>
              <a:endParaRPr kumimoji="1" lang="ja-JP" altLang="en-US" sz="1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テキスト ボックス 2">
            <a:extLst>
              <a:ext uri="{FF2B5EF4-FFF2-40B4-BE49-F238E27FC236}">
                <a16:creationId xmlns:a16="http://schemas.microsoft.com/office/drawing/2014/main" id="{8AB2E0D5-8738-3E6F-818D-2D40910864F8}"/>
              </a:ext>
            </a:extLst>
          </p:cNvPr>
          <p:cNvSpPr txBox="1"/>
          <p:nvPr/>
        </p:nvSpPr>
        <p:spPr>
          <a:xfrm rot="16200000">
            <a:off x="-1268058" y="2835171"/>
            <a:ext cx="2993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prescription rate (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CFDAF0A-5B8D-4910-8910-862E5EBC02BC}"/>
              </a:ext>
            </a:extLst>
          </p:cNvPr>
          <p:cNvSpPr txBox="1"/>
          <p:nvPr/>
        </p:nvSpPr>
        <p:spPr>
          <a:xfrm>
            <a:off x="205270" y="185285"/>
            <a:ext cx="857990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es of antiviral prescription by generalists among patients without risk factors for disease progression before and after viewing the educational film. Pre, before viewing the educational film; post, after viewing the educational film.</a:t>
            </a:r>
            <a:endParaRPr kumimoji="1" lang="ja-JP" altLang="en-US" sz="1600" b="1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25581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49ADD1B1-CE95-D277-7795-6C6135B7F934}"/>
              </a:ext>
            </a:extLst>
          </p:cNvPr>
          <p:cNvGrpSpPr/>
          <p:nvPr/>
        </p:nvGrpSpPr>
        <p:grpSpPr>
          <a:xfrm>
            <a:off x="0" y="553096"/>
            <a:ext cx="9079206" cy="6174275"/>
            <a:chOff x="0" y="553096"/>
            <a:chExt cx="9079206" cy="6174275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043A4E23-667C-4479-B300-FDB40B225E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53096"/>
              <a:ext cx="9079206" cy="6174275"/>
            </a:xfrm>
            <a:prstGeom prst="rect">
              <a:avLst/>
            </a:prstGeom>
          </p:spPr>
        </p:pic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C6E5C1C2-93BB-908F-3C73-EBB945FB15C5}"/>
                </a:ext>
              </a:extLst>
            </p:cNvPr>
            <p:cNvSpPr txBox="1"/>
            <p:nvPr/>
          </p:nvSpPr>
          <p:spPr>
            <a:xfrm>
              <a:off x="3358245" y="1057089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2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B2BCEA27-F1AF-6B3C-C270-AE11641E08F0}"/>
                </a:ext>
              </a:extLst>
            </p:cNvPr>
            <p:cNvSpPr txBox="1"/>
            <p:nvPr/>
          </p:nvSpPr>
          <p:spPr>
            <a:xfrm>
              <a:off x="1415144" y="1057089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05A3024-910A-EF9D-ACC4-26CE624C5C42}"/>
                </a:ext>
              </a:extLst>
            </p:cNvPr>
            <p:cNvSpPr txBox="1"/>
            <p:nvPr/>
          </p:nvSpPr>
          <p:spPr>
            <a:xfrm>
              <a:off x="5501951" y="1057088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3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0F2A6F0A-1AE5-8DD5-C829-2837C7E94296}"/>
                </a:ext>
              </a:extLst>
            </p:cNvPr>
            <p:cNvSpPr txBox="1"/>
            <p:nvPr/>
          </p:nvSpPr>
          <p:spPr>
            <a:xfrm>
              <a:off x="7522030" y="1057081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4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テキスト ボックス 2">
            <a:extLst>
              <a:ext uri="{FF2B5EF4-FFF2-40B4-BE49-F238E27FC236}">
                <a16:creationId xmlns:a16="http://schemas.microsoft.com/office/drawing/2014/main" id="{375A42C0-A159-094E-8965-F1645A59EA4A}"/>
              </a:ext>
            </a:extLst>
          </p:cNvPr>
          <p:cNvSpPr txBox="1"/>
          <p:nvPr/>
        </p:nvSpPr>
        <p:spPr>
          <a:xfrm rot="16200000">
            <a:off x="-1268058" y="2748676"/>
            <a:ext cx="2993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prescription rate (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24BE1E9-0F0A-4A22-BA2A-62AAA1EF8FD0}"/>
              </a:ext>
            </a:extLst>
          </p:cNvPr>
          <p:cNvSpPr txBox="1"/>
          <p:nvPr/>
        </p:nvSpPr>
        <p:spPr>
          <a:xfrm>
            <a:off x="149287" y="46652"/>
            <a:ext cx="87228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es of antiviral prescription by nongeneralists among patients with immunosuppressed status before and after viewing the educational film. Pre, before viewing the educational film; post, after viewing the educational film. </a:t>
            </a:r>
            <a:endParaRPr kumimoji="1" lang="en-US" altLang="ja-JP" sz="1600" b="1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13686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7C14FFD2-979D-C6F1-FC09-37065064AE9F}"/>
              </a:ext>
            </a:extLst>
          </p:cNvPr>
          <p:cNvGrpSpPr/>
          <p:nvPr/>
        </p:nvGrpSpPr>
        <p:grpSpPr>
          <a:xfrm>
            <a:off x="0" y="678987"/>
            <a:ext cx="9086172" cy="6179013"/>
            <a:chOff x="0" y="678987"/>
            <a:chExt cx="9086172" cy="6179013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C1A344F7-2FB3-416A-B916-1E091E1093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678987"/>
              <a:ext cx="9086172" cy="6179013"/>
            </a:xfrm>
            <a:prstGeom prst="rect">
              <a:avLst/>
            </a:prstGeom>
          </p:spPr>
        </p:pic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206FD55F-5519-A5F4-5A65-4C193FAAD9A3}"/>
                </a:ext>
              </a:extLst>
            </p:cNvPr>
            <p:cNvSpPr txBox="1"/>
            <p:nvPr/>
          </p:nvSpPr>
          <p:spPr>
            <a:xfrm>
              <a:off x="3314701" y="1176831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6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CFE96164-1DC6-D893-CE04-A824A24953DC}"/>
                </a:ext>
              </a:extLst>
            </p:cNvPr>
            <p:cNvSpPr txBox="1"/>
            <p:nvPr/>
          </p:nvSpPr>
          <p:spPr>
            <a:xfrm>
              <a:off x="1371600" y="1176829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5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A1C98E05-444B-0AAB-3D2A-81B707A9C469}"/>
                </a:ext>
              </a:extLst>
            </p:cNvPr>
            <p:cNvSpPr txBox="1"/>
            <p:nvPr/>
          </p:nvSpPr>
          <p:spPr>
            <a:xfrm>
              <a:off x="5458407" y="1176825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7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8A2D8899-7C57-28EF-F532-896BB789E391}"/>
                </a:ext>
              </a:extLst>
            </p:cNvPr>
            <p:cNvSpPr txBox="1"/>
            <p:nvPr/>
          </p:nvSpPr>
          <p:spPr>
            <a:xfrm>
              <a:off x="7478486" y="1176829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8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テキスト ボックス 2">
            <a:extLst>
              <a:ext uri="{FF2B5EF4-FFF2-40B4-BE49-F238E27FC236}">
                <a16:creationId xmlns:a16="http://schemas.microsoft.com/office/drawing/2014/main" id="{9A9EA575-BAA2-5A1F-08E8-A988B7CF8A18}"/>
              </a:ext>
            </a:extLst>
          </p:cNvPr>
          <p:cNvSpPr txBox="1"/>
          <p:nvPr/>
        </p:nvSpPr>
        <p:spPr>
          <a:xfrm rot="16200000">
            <a:off x="-1268058" y="2896959"/>
            <a:ext cx="2993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prescription rate (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8D4BE5A-7B19-4815-B2A9-798403AA0C9C}"/>
              </a:ext>
            </a:extLst>
          </p:cNvPr>
          <p:cNvSpPr txBox="1"/>
          <p:nvPr/>
        </p:nvSpPr>
        <p:spPr>
          <a:xfrm>
            <a:off x="205271" y="185285"/>
            <a:ext cx="863508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es of antiviral prescription by nongeneralists among patients with obesity before and after viewing the educational film. Pre, before viewing the educational film; post, after viewing the educational film.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600" b="1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39057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1DE2BF6F-41C7-A5D6-596D-065953926456}"/>
              </a:ext>
            </a:extLst>
          </p:cNvPr>
          <p:cNvGrpSpPr/>
          <p:nvPr/>
        </p:nvGrpSpPr>
        <p:grpSpPr>
          <a:xfrm>
            <a:off x="0" y="623003"/>
            <a:ext cx="9045010" cy="6151021"/>
            <a:chOff x="0" y="623003"/>
            <a:chExt cx="9045010" cy="6151021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52A077CA-9331-491E-BADA-04BC916D2A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623003"/>
              <a:ext cx="9045010" cy="6151021"/>
            </a:xfrm>
            <a:prstGeom prst="rect">
              <a:avLst/>
            </a:prstGeom>
          </p:spPr>
        </p:pic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270DC128-1B9E-33F6-4C85-01BD25BC75C2}"/>
                </a:ext>
              </a:extLst>
            </p:cNvPr>
            <p:cNvSpPr txBox="1"/>
            <p:nvPr/>
          </p:nvSpPr>
          <p:spPr>
            <a:xfrm>
              <a:off x="3260271" y="1123875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69C28AB9-92C3-884E-F998-7DCA75B31F20}"/>
                </a:ext>
              </a:extLst>
            </p:cNvPr>
            <p:cNvSpPr txBox="1"/>
            <p:nvPr/>
          </p:nvSpPr>
          <p:spPr>
            <a:xfrm>
              <a:off x="1317170" y="1123873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9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0C9C9207-8C93-445E-FCB7-75FD1A15DD51}"/>
                </a:ext>
              </a:extLst>
            </p:cNvPr>
            <p:cNvSpPr txBox="1"/>
            <p:nvPr/>
          </p:nvSpPr>
          <p:spPr>
            <a:xfrm>
              <a:off x="5403977" y="1123875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1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C2E0359-41DD-10BE-9F9D-7243762681A9}"/>
                </a:ext>
              </a:extLst>
            </p:cNvPr>
            <p:cNvSpPr txBox="1"/>
            <p:nvPr/>
          </p:nvSpPr>
          <p:spPr>
            <a:xfrm>
              <a:off x="7424056" y="1123871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2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テキスト ボックス 2">
            <a:extLst>
              <a:ext uri="{FF2B5EF4-FFF2-40B4-BE49-F238E27FC236}">
                <a16:creationId xmlns:a16="http://schemas.microsoft.com/office/drawing/2014/main" id="{2B870B54-B6F4-C0B2-3ADB-72BF8094F3EE}"/>
              </a:ext>
            </a:extLst>
          </p:cNvPr>
          <p:cNvSpPr txBox="1"/>
          <p:nvPr/>
        </p:nvSpPr>
        <p:spPr>
          <a:xfrm rot="16200000">
            <a:off x="-1268058" y="2810459"/>
            <a:ext cx="2993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prescription rate (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DE9F27E-D1D4-4216-9031-C5B36982C526}"/>
              </a:ext>
            </a:extLst>
          </p:cNvPr>
          <p:cNvSpPr txBox="1"/>
          <p:nvPr/>
        </p:nvSpPr>
        <p:spPr>
          <a:xfrm>
            <a:off x="205271" y="185285"/>
            <a:ext cx="864296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es of antiviral prescription by nongeneralists among patients with hypertension or hyperlipidemia before and after viewing the educational film. Pre, before viewing the educational film; post, after viewing the educational film.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22934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8746352-A425-EE21-F4F2-1C0ECAF3780F}"/>
              </a:ext>
            </a:extLst>
          </p:cNvPr>
          <p:cNvGrpSpPr/>
          <p:nvPr/>
        </p:nvGrpSpPr>
        <p:grpSpPr>
          <a:xfrm>
            <a:off x="0" y="568591"/>
            <a:ext cx="9050694" cy="6154886"/>
            <a:chOff x="0" y="568591"/>
            <a:chExt cx="9050694" cy="6154886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0D97712D-87E9-461E-84A1-5A2FF23070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68591"/>
              <a:ext cx="9050694" cy="6154886"/>
            </a:xfrm>
            <a:prstGeom prst="rect">
              <a:avLst/>
            </a:prstGeom>
          </p:spPr>
        </p:pic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D29D45A4-F93A-66B8-8891-B20583FF1B18}"/>
                </a:ext>
              </a:extLst>
            </p:cNvPr>
            <p:cNvSpPr txBox="1"/>
            <p:nvPr/>
          </p:nvSpPr>
          <p:spPr>
            <a:xfrm>
              <a:off x="3271157" y="1069443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4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AC9E509B-845C-570C-928D-5AA7E684A238}"/>
                </a:ext>
              </a:extLst>
            </p:cNvPr>
            <p:cNvSpPr txBox="1"/>
            <p:nvPr/>
          </p:nvSpPr>
          <p:spPr>
            <a:xfrm>
              <a:off x="1328056" y="1069443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3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40ED3BAA-4A9E-E016-E952-0A59C561C31D}"/>
                </a:ext>
              </a:extLst>
            </p:cNvPr>
            <p:cNvSpPr txBox="1"/>
            <p:nvPr/>
          </p:nvSpPr>
          <p:spPr>
            <a:xfrm>
              <a:off x="5414863" y="1069442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5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AEC86A85-F228-8693-54F9-9D3A93C82259}"/>
                </a:ext>
              </a:extLst>
            </p:cNvPr>
            <p:cNvSpPr txBox="1"/>
            <p:nvPr/>
          </p:nvSpPr>
          <p:spPr>
            <a:xfrm>
              <a:off x="7434942" y="1069442"/>
              <a:ext cx="12409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 16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テキスト ボックス 2">
            <a:extLst>
              <a:ext uri="{FF2B5EF4-FFF2-40B4-BE49-F238E27FC236}">
                <a16:creationId xmlns:a16="http://schemas.microsoft.com/office/drawing/2014/main" id="{35EC4CD9-6F20-B048-6F45-830D4584E13C}"/>
              </a:ext>
            </a:extLst>
          </p:cNvPr>
          <p:cNvSpPr txBox="1"/>
          <p:nvPr/>
        </p:nvSpPr>
        <p:spPr>
          <a:xfrm rot="16200000">
            <a:off x="-1268058" y="2773389"/>
            <a:ext cx="2993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prescription rate (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3B150EF-21F1-4601-9662-984CF529481D}"/>
              </a:ext>
            </a:extLst>
          </p:cNvPr>
          <p:cNvSpPr txBox="1"/>
          <p:nvPr/>
        </p:nvSpPr>
        <p:spPr>
          <a:xfrm>
            <a:off x="205271" y="185285"/>
            <a:ext cx="884542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es of antiviral prescription by nongeneralists among patients without risk factors for disease progression before and after viewing the educational film. Pre, before viewing the educational film; post, after viewing the educational film.</a:t>
            </a:r>
            <a:endParaRPr kumimoji="1" lang="ja-JP" altLang="en-US" sz="1600" b="1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5121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8</TotalTime>
  <Words>407</Words>
  <Application>Microsoft Office PowerPoint</Application>
  <PresentationFormat>画面に合わせる (4:3)</PresentationFormat>
  <Paragraphs>48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miya</dc:creator>
  <cp:lastModifiedBy>Komiya</cp:lastModifiedBy>
  <cp:revision>9</cp:revision>
  <dcterms:created xsi:type="dcterms:W3CDTF">2025-01-29T07:27:34Z</dcterms:created>
  <dcterms:modified xsi:type="dcterms:W3CDTF">2025-02-13T11:46:17Z</dcterms:modified>
</cp:coreProperties>
</file>